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87" r:id="rId2"/>
  </p:sldIdLst>
  <p:sldSz cx="6858000" cy="9906000" type="A4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C17F8"/>
    <a:srgbClr val="4B76FF"/>
    <a:srgbClr val="FF4343"/>
    <a:srgbClr val="50FF19"/>
    <a:srgbClr val="FF0066"/>
  </p:clrMru>
  <p:extLst>
    <p:ext uri="{E76CE94A-603C-4142-B9EB-6D1370010A27}">
      <p14:discardImageEditData xmlns:p14="http://schemas.microsoft.com/office/powerpoint/2010/main" val="1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3D2B2A1-20A6-4E2F-A68E-4738F8963BC9}" v="1" dt="2024-11-14T02:16:48.50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6242" autoAdjust="0"/>
  </p:normalViewPr>
  <p:slideViewPr>
    <p:cSldViewPr snapToGrid="0">
      <p:cViewPr>
        <p:scale>
          <a:sx n="118" d="100"/>
          <a:sy n="118" d="100"/>
        </p:scale>
        <p:origin x="228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kizaki satoru" userId="c4948fec-e96c-4c67-b6e6-2460f4ee40c5" providerId="ADAL" clId="{73D2B2A1-20A6-4E2F-A68E-4738F8963BC9}"/>
    <pc:docChg chg="undo custSel modSld">
      <pc:chgData name="kakizaki satoru" userId="c4948fec-e96c-4c67-b6e6-2460f4ee40c5" providerId="ADAL" clId="{73D2B2A1-20A6-4E2F-A68E-4738F8963BC9}" dt="2024-11-14T02:20:42.118" v="13" actId="20577"/>
      <pc:docMkLst>
        <pc:docMk/>
      </pc:docMkLst>
      <pc:sldChg chg="addSp modSp mod">
        <pc:chgData name="kakizaki satoru" userId="c4948fec-e96c-4c67-b6e6-2460f4ee40c5" providerId="ADAL" clId="{73D2B2A1-20A6-4E2F-A68E-4738F8963BC9}" dt="2024-11-14T02:20:42.118" v="13" actId="20577"/>
        <pc:sldMkLst>
          <pc:docMk/>
          <pc:sldMk cId="1160370529" sldId="287"/>
        </pc:sldMkLst>
        <pc:spChg chg="mod">
          <ac:chgData name="kakizaki satoru" userId="c4948fec-e96c-4c67-b6e6-2460f4ee40c5" providerId="ADAL" clId="{73D2B2A1-20A6-4E2F-A68E-4738F8963BC9}" dt="2024-11-14T02:20:42.118" v="13" actId="20577"/>
          <ac:spMkLst>
            <pc:docMk/>
            <pc:sldMk cId="1160370529" sldId="287"/>
            <ac:spMk id="2" creationId="{C7F2344A-1B17-130B-24ED-8886AAAD71BE}"/>
          </ac:spMkLst>
        </pc:spChg>
        <pc:spChg chg="add mod">
          <ac:chgData name="kakizaki satoru" userId="c4948fec-e96c-4c67-b6e6-2460f4ee40c5" providerId="ADAL" clId="{73D2B2A1-20A6-4E2F-A68E-4738F8963BC9}" dt="2024-11-14T02:18:09.749" v="5" actId="404"/>
          <ac:spMkLst>
            <pc:docMk/>
            <pc:sldMk cId="1160370529" sldId="287"/>
            <ac:spMk id="3" creationId="{66F14411-C180-1A18-FE9B-B21777861672}"/>
          </ac:spMkLst>
        </pc:spChg>
        <pc:spChg chg="mod">
          <ac:chgData name="kakizaki satoru" userId="c4948fec-e96c-4c67-b6e6-2460f4ee40c5" providerId="ADAL" clId="{73D2B2A1-20A6-4E2F-A68E-4738F8963BC9}" dt="2024-11-14T02:18:09.749" v="5" actId="404"/>
          <ac:spMkLst>
            <pc:docMk/>
            <pc:sldMk cId="1160370529" sldId="287"/>
            <ac:spMk id="11" creationId="{9B02125A-1A6C-08D2-1EA1-FADA72ABC5E8}"/>
          </ac:spMkLst>
        </pc:spChg>
        <pc:spChg chg="mod">
          <ac:chgData name="kakizaki satoru" userId="c4948fec-e96c-4c67-b6e6-2460f4ee40c5" providerId="ADAL" clId="{73D2B2A1-20A6-4E2F-A68E-4738F8963BC9}" dt="2024-11-14T02:18:09.749" v="5" actId="404"/>
          <ac:spMkLst>
            <pc:docMk/>
            <pc:sldMk cId="1160370529" sldId="287"/>
            <ac:spMk id="17" creationId="{2F89C8E0-B6D4-A247-65A5-DEA1A3D73F57}"/>
          </ac:spMkLst>
        </pc:spChg>
        <pc:spChg chg="mod">
          <ac:chgData name="kakizaki satoru" userId="c4948fec-e96c-4c67-b6e6-2460f4ee40c5" providerId="ADAL" clId="{73D2B2A1-20A6-4E2F-A68E-4738F8963BC9}" dt="2024-11-14T02:18:09.749" v="5" actId="404"/>
          <ac:spMkLst>
            <pc:docMk/>
            <pc:sldMk cId="1160370529" sldId="287"/>
            <ac:spMk id="18" creationId="{C197D255-E7F1-5733-0FAE-4025C5B17632}"/>
          </ac:spMkLst>
        </pc:spChg>
        <pc:spChg chg="mod">
          <ac:chgData name="kakizaki satoru" userId="c4948fec-e96c-4c67-b6e6-2460f4ee40c5" providerId="ADAL" clId="{73D2B2A1-20A6-4E2F-A68E-4738F8963BC9}" dt="2024-11-14T02:18:09.749" v="5" actId="404"/>
          <ac:spMkLst>
            <pc:docMk/>
            <pc:sldMk cId="1160370529" sldId="287"/>
            <ac:spMk id="19" creationId="{BCE4FAC5-5019-687E-1563-B8F77D0815D3}"/>
          </ac:spMkLst>
        </pc:spChg>
        <pc:spChg chg="mod">
          <ac:chgData name="kakizaki satoru" userId="c4948fec-e96c-4c67-b6e6-2460f4ee40c5" providerId="ADAL" clId="{73D2B2A1-20A6-4E2F-A68E-4738F8963BC9}" dt="2024-11-14T02:18:09.749" v="5" actId="404"/>
          <ac:spMkLst>
            <pc:docMk/>
            <pc:sldMk cId="1160370529" sldId="287"/>
            <ac:spMk id="20" creationId="{D2E6F3D0-18E8-6BC9-786E-2B8C75635C0A}"/>
          </ac:spMkLst>
        </pc:spChg>
        <pc:spChg chg="mod">
          <ac:chgData name="kakizaki satoru" userId="c4948fec-e96c-4c67-b6e6-2460f4ee40c5" providerId="ADAL" clId="{73D2B2A1-20A6-4E2F-A68E-4738F8963BC9}" dt="2024-11-14T02:18:09.749" v="5" actId="404"/>
          <ac:spMkLst>
            <pc:docMk/>
            <pc:sldMk cId="1160370529" sldId="287"/>
            <ac:spMk id="21" creationId="{1B62BE2B-98EB-B5A1-3EA0-A1BA09CED93E}"/>
          </ac:spMkLst>
        </pc:spChg>
        <pc:spChg chg="mod">
          <ac:chgData name="kakizaki satoru" userId="c4948fec-e96c-4c67-b6e6-2460f4ee40c5" providerId="ADAL" clId="{73D2B2A1-20A6-4E2F-A68E-4738F8963BC9}" dt="2024-11-14T02:18:09.749" v="5" actId="404"/>
          <ac:spMkLst>
            <pc:docMk/>
            <pc:sldMk cId="1160370529" sldId="287"/>
            <ac:spMk id="22" creationId="{E52DAAA2-351F-A91E-FDE4-F18ED04B9EB6}"/>
          </ac:spMkLst>
        </pc:spChg>
        <pc:spChg chg="mod">
          <ac:chgData name="kakizaki satoru" userId="c4948fec-e96c-4c67-b6e6-2460f4ee40c5" providerId="ADAL" clId="{73D2B2A1-20A6-4E2F-A68E-4738F8963BC9}" dt="2024-11-14T02:18:09.749" v="5" actId="404"/>
          <ac:spMkLst>
            <pc:docMk/>
            <pc:sldMk cId="1160370529" sldId="287"/>
            <ac:spMk id="23" creationId="{9E7721C1-D884-760D-5DB6-C9671EA730A0}"/>
          </ac:spMkLst>
        </pc:spChg>
        <pc:spChg chg="mod">
          <ac:chgData name="kakizaki satoru" userId="c4948fec-e96c-4c67-b6e6-2460f4ee40c5" providerId="ADAL" clId="{73D2B2A1-20A6-4E2F-A68E-4738F8963BC9}" dt="2024-11-14T02:18:09.749" v="5" actId="404"/>
          <ac:spMkLst>
            <pc:docMk/>
            <pc:sldMk cId="1160370529" sldId="287"/>
            <ac:spMk id="24" creationId="{AE317392-04D3-97CD-DDFA-44D1A3BA24B6}"/>
          </ac:spMkLst>
        </pc:spChg>
        <pc:spChg chg="mod">
          <ac:chgData name="kakizaki satoru" userId="c4948fec-e96c-4c67-b6e6-2460f4ee40c5" providerId="ADAL" clId="{73D2B2A1-20A6-4E2F-A68E-4738F8963BC9}" dt="2024-11-14T02:18:09.749" v="5" actId="404"/>
          <ac:spMkLst>
            <pc:docMk/>
            <pc:sldMk cId="1160370529" sldId="287"/>
            <ac:spMk id="25" creationId="{AB891FE4-1C35-CADD-95AC-E8A40F931857}"/>
          </ac:spMkLst>
        </pc:spChg>
        <pc:spChg chg="mod">
          <ac:chgData name="kakizaki satoru" userId="c4948fec-e96c-4c67-b6e6-2460f4ee40c5" providerId="ADAL" clId="{73D2B2A1-20A6-4E2F-A68E-4738F8963BC9}" dt="2024-11-14T02:18:09.749" v="5" actId="404"/>
          <ac:spMkLst>
            <pc:docMk/>
            <pc:sldMk cId="1160370529" sldId="287"/>
            <ac:spMk id="26" creationId="{8010F803-82C3-C69A-2ED6-B8BFAB1A7911}"/>
          </ac:spMkLst>
        </pc:spChg>
        <pc:spChg chg="mod">
          <ac:chgData name="kakizaki satoru" userId="c4948fec-e96c-4c67-b6e6-2460f4ee40c5" providerId="ADAL" clId="{73D2B2A1-20A6-4E2F-A68E-4738F8963BC9}" dt="2024-11-14T02:18:09.749" v="5" actId="404"/>
          <ac:spMkLst>
            <pc:docMk/>
            <pc:sldMk cId="1160370529" sldId="287"/>
            <ac:spMk id="27" creationId="{C7BDBF9E-075D-5705-6D8C-7F270CE6EC21}"/>
          </ac:spMkLst>
        </pc:spChg>
        <pc:spChg chg="mod">
          <ac:chgData name="kakizaki satoru" userId="c4948fec-e96c-4c67-b6e6-2460f4ee40c5" providerId="ADAL" clId="{73D2B2A1-20A6-4E2F-A68E-4738F8963BC9}" dt="2024-11-14T02:18:09.749" v="5" actId="404"/>
          <ac:spMkLst>
            <pc:docMk/>
            <pc:sldMk cId="1160370529" sldId="287"/>
            <ac:spMk id="28" creationId="{A251CDC4-221F-07FB-CE29-A224A7FDB933}"/>
          </ac:spMkLst>
        </pc:spChg>
        <pc:spChg chg="mod">
          <ac:chgData name="kakizaki satoru" userId="c4948fec-e96c-4c67-b6e6-2460f4ee40c5" providerId="ADAL" clId="{73D2B2A1-20A6-4E2F-A68E-4738F8963BC9}" dt="2024-11-14T02:18:09.749" v="5" actId="404"/>
          <ac:spMkLst>
            <pc:docMk/>
            <pc:sldMk cId="1160370529" sldId="287"/>
            <ac:spMk id="30" creationId="{243E1EC1-4589-8348-5DD5-F0DCEAB6439A}"/>
          </ac:spMkLst>
        </pc:spChg>
        <pc:spChg chg="mod">
          <ac:chgData name="kakizaki satoru" userId="c4948fec-e96c-4c67-b6e6-2460f4ee40c5" providerId="ADAL" clId="{73D2B2A1-20A6-4E2F-A68E-4738F8963BC9}" dt="2024-11-14T02:18:09.749" v="5" actId="404"/>
          <ac:spMkLst>
            <pc:docMk/>
            <pc:sldMk cId="1160370529" sldId="287"/>
            <ac:spMk id="31" creationId="{F556A42C-2837-06C6-58CF-AD3629B52FE3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469572D-DE93-4534-A293-4B058188293E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3138" y="1243013"/>
            <a:ext cx="2320925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83307"/>
            <a:ext cx="5445760" cy="3913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E700A6-2632-4E6C-8DBE-11ABD168A8D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38090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243138" y="1243013"/>
            <a:ext cx="2320925" cy="3354387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DF8107-3712-4D8C-96B0-2D56D56CB96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56715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C3D9B-4951-4037-B647-6E9DC5D9AE45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DBDF-FD1F-4A9C-900B-EF4DEF6B84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69267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C3D9B-4951-4037-B647-6E9DC5D9AE45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DBDF-FD1F-4A9C-900B-EF4DEF6B84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11145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C3D9B-4951-4037-B647-6E9DC5D9AE45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DBDF-FD1F-4A9C-900B-EF4DEF6B84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99206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C3D9B-4951-4037-B647-6E9DC5D9AE45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DBDF-FD1F-4A9C-900B-EF4DEF6B84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28748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C3D9B-4951-4037-B647-6E9DC5D9AE45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DBDF-FD1F-4A9C-900B-EF4DEF6B84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30071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C3D9B-4951-4037-B647-6E9DC5D9AE45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DBDF-FD1F-4A9C-900B-EF4DEF6B84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29284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C3D9B-4951-4037-B647-6E9DC5D9AE45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DBDF-FD1F-4A9C-900B-EF4DEF6B84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3500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C3D9B-4951-4037-B647-6E9DC5D9AE45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DBDF-FD1F-4A9C-900B-EF4DEF6B84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28457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C3D9B-4951-4037-B647-6E9DC5D9AE45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DBDF-FD1F-4A9C-900B-EF4DEF6B84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97173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C3D9B-4951-4037-B647-6E9DC5D9AE45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DBDF-FD1F-4A9C-900B-EF4DEF6B84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40200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7C3D9B-4951-4037-B647-6E9DC5D9AE45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B9DBDF-FD1F-4A9C-900B-EF4DEF6B84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68433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7C3D9B-4951-4037-B647-6E9DC5D9AE45}" type="datetimeFigureOut">
              <a:rPr kumimoji="1" lang="ja-JP" altLang="en-US" smtClean="0"/>
              <a:t>2024/1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B9DBDF-FD1F-4A9C-900B-EF4DEF6B84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67482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四角形: 角を丸くする 30">
            <a:extLst>
              <a:ext uri="{FF2B5EF4-FFF2-40B4-BE49-F238E27FC236}">
                <a16:creationId xmlns:a16="http://schemas.microsoft.com/office/drawing/2014/main" id="{F556A42C-2837-06C6-58CF-AD3629B52FE3}"/>
              </a:ext>
            </a:extLst>
          </p:cNvPr>
          <p:cNvSpPr/>
          <p:nvPr/>
        </p:nvSpPr>
        <p:spPr>
          <a:xfrm>
            <a:off x="2084316" y="1245140"/>
            <a:ext cx="4556432" cy="1874196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四角形: 角を丸くする 29">
            <a:extLst>
              <a:ext uri="{FF2B5EF4-FFF2-40B4-BE49-F238E27FC236}">
                <a16:creationId xmlns:a16="http://schemas.microsoft.com/office/drawing/2014/main" id="{243E1EC1-4589-8348-5DD5-F0DCEAB6439A}"/>
              </a:ext>
            </a:extLst>
          </p:cNvPr>
          <p:cNvSpPr/>
          <p:nvPr/>
        </p:nvSpPr>
        <p:spPr>
          <a:xfrm>
            <a:off x="281324" y="1245140"/>
            <a:ext cx="1606484" cy="1874196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9B02125A-1A6C-08D2-1EA1-FADA72ABC5E8}"/>
              </a:ext>
            </a:extLst>
          </p:cNvPr>
          <p:cNvSpPr txBox="1"/>
          <p:nvPr/>
        </p:nvSpPr>
        <p:spPr>
          <a:xfrm>
            <a:off x="379249" y="2219820"/>
            <a:ext cx="1410641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creenig 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eriod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Days to -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F89C8E0-B6D4-A247-65A5-DEA1A3D73F57}"/>
              </a:ext>
            </a:extLst>
          </p:cNvPr>
          <p:cNvSpPr txBox="1"/>
          <p:nvPr/>
        </p:nvSpPr>
        <p:spPr>
          <a:xfrm>
            <a:off x="667967" y="1855371"/>
            <a:ext cx="83320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Visit 1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C197D255-E7F1-5733-0FAE-4025C5B17632}"/>
              </a:ext>
            </a:extLst>
          </p:cNvPr>
          <p:cNvSpPr txBox="1"/>
          <p:nvPr/>
        </p:nvSpPr>
        <p:spPr>
          <a:xfrm>
            <a:off x="2178861" y="2219820"/>
            <a:ext cx="943715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aseline/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Day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BCE4FAC5-5019-687E-1563-B8F77D0815D3}"/>
              </a:ext>
            </a:extLst>
          </p:cNvPr>
          <p:cNvSpPr txBox="1"/>
          <p:nvPr/>
        </p:nvSpPr>
        <p:spPr>
          <a:xfrm>
            <a:off x="2229184" y="1855371"/>
            <a:ext cx="83320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Visit 2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D2E6F3D0-18E8-6BC9-786E-2B8C75635C0A}"/>
              </a:ext>
            </a:extLst>
          </p:cNvPr>
          <p:cNvSpPr txBox="1"/>
          <p:nvPr/>
        </p:nvSpPr>
        <p:spPr>
          <a:xfrm>
            <a:off x="3206752" y="2219820"/>
            <a:ext cx="943715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Day 5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1B62BE2B-98EB-B5A1-3EA0-A1BA09CED93E}"/>
              </a:ext>
            </a:extLst>
          </p:cNvPr>
          <p:cNvSpPr txBox="1"/>
          <p:nvPr/>
        </p:nvSpPr>
        <p:spPr>
          <a:xfrm>
            <a:off x="3262007" y="1850488"/>
            <a:ext cx="83320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Visit 3</a:t>
            </a: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E52DAAA2-351F-A91E-FDE4-F18ED04B9EB6}"/>
              </a:ext>
            </a:extLst>
          </p:cNvPr>
          <p:cNvSpPr txBox="1"/>
          <p:nvPr/>
        </p:nvSpPr>
        <p:spPr>
          <a:xfrm>
            <a:off x="4234642" y="2219820"/>
            <a:ext cx="943715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rocedure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Day 8-13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9E7721C1-D884-760D-5DB6-C9671EA730A0}"/>
              </a:ext>
            </a:extLst>
          </p:cNvPr>
          <p:cNvSpPr txBox="1"/>
          <p:nvPr/>
        </p:nvSpPr>
        <p:spPr>
          <a:xfrm>
            <a:off x="4289898" y="1850488"/>
            <a:ext cx="83320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Visit 4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E317392-04D3-97CD-DDFA-44D1A3BA24B6}"/>
              </a:ext>
            </a:extLst>
          </p:cNvPr>
          <p:cNvSpPr txBox="1"/>
          <p:nvPr/>
        </p:nvSpPr>
        <p:spPr>
          <a:xfrm>
            <a:off x="5262532" y="2219820"/>
            <a:ext cx="1248511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7-14 days post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rocedure</a:t>
            </a:r>
          </a:p>
          <a:p>
            <a:pPr algn="ctr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Day 15-27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AB891FE4-1C35-CADD-95AC-E8A40F931857}"/>
              </a:ext>
            </a:extLst>
          </p:cNvPr>
          <p:cNvSpPr txBox="1"/>
          <p:nvPr/>
        </p:nvSpPr>
        <p:spPr>
          <a:xfrm>
            <a:off x="5470185" y="1852721"/>
            <a:ext cx="83320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Visit 5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8010F803-82C3-C69A-2ED6-B8BFAB1A7911}"/>
              </a:ext>
            </a:extLst>
          </p:cNvPr>
          <p:cNvSpPr txBox="1"/>
          <p:nvPr/>
        </p:nvSpPr>
        <p:spPr>
          <a:xfrm>
            <a:off x="460312" y="1365369"/>
            <a:ext cx="1248514" cy="276999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e-treatment</a:t>
            </a:r>
            <a:endParaRPr kumimoji="1" lang="ja-JP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C7BDBF9E-075D-5705-6D8C-7F270CE6EC21}"/>
              </a:ext>
            </a:extLst>
          </p:cNvPr>
          <p:cNvSpPr txBox="1"/>
          <p:nvPr/>
        </p:nvSpPr>
        <p:spPr>
          <a:xfrm>
            <a:off x="2300523" y="1365368"/>
            <a:ext cx="2756172" cy="276999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usutrombopag treatment</a:t>
            </a:r>
            <a:endParaRPr kumimoji="1" lang="ja-JP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A251CDC4-221F-07FB-CE29-A224A7FDB933}"/>
              </a:ext>
            </a:extLst>
          </p:cNvPr>
          <p:cNvSpPr txBox="1"/>
          <p:nvPr/>
        </p:nvSpPr>
        <p:spPr>
          <a:xfrm>
            <a:off x="5431144" y="1365368"/>
            <a:ext cx="911285" cy="276999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llow-up</a:t>
            </a:r>
            <a:endParaRPr kumimoji="1" lang="ja-JP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7F2344A-1B17-130B-24ED-8886AAAD71BE}"/>
              </a:ext>
            </a:extLst>
          </p:cNvPr>
          <p:cNvSpPr txBox="1"/>
          <p:nvPr/>
        </p:nvSpPr>
        <p:spPr>
          <a:xfrm>
            <a:off x="281323" y="3340748"/>
            <a:ext cx="622971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he planned invasive procedure was conducted 8 to 13 days after initiation of lusutrombopag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usutrombopag is administered orally at a dose of 3 mg once daily for 7 days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t is recommended to measure platelet counts 5 days after </a:t>
            </a: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starting lusutrombopag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96">
            <a:extLst>
              <a:ext uri="{FF2B5EF4-FFF2-40B4-BE49-F238E27FC236}">
                <a16:creationId xmlns:a16="http://schemas.microsoft.com/office/drawing/2014/main" id="{66F14411-C180-1A18-FE9B-B21777861672}"/>
              </a:ext>
            </a:extLst>
          </p:cNvPr>
          <p:cNvSpPr txBox="1"/>
          <p:nvPr/>
        </p:nvSpPr>
        <p:spPr>
          <a:xfrm>
            <a:off x="0" y="0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603705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938</TotalTime>
  <Words>95</Words>
  <Application>Microsoft Office PowerPoint</Application>
  <PresentationFormat>A4 210 x 297 mm</PresentationFormat>
  <Paragraphs>26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>Toshib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UGA</dc:creator>
  <cp:lastModifiedBy>kakizaki satoru</cp:lastModifiedBy>
  <cp:revision>656</cp:revision>
  <cp:lastPrinted>2017-11-21T01:24:45Z</cp:lastPrinted>
  <dcterms:created xsi:type="dcterms:W3CDTF">2017-06-01T03:00:03Z</dcterms:created>
  <dcterms:modified xsi:type="dcterms:W3CDTF">2024-11-14T02:20:47Z</dcterms:modified>
</cp:coreProperties>
</file>